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6" r:id="rId2"/>
    <p:sldId id="274" r:id="rId3"/>
    <p:sldId id="275" r:id="rId4"/>
    <p:sldId id="265" r:id="rId5"/>
    <p:sldId id="260" r:id="rId6"/>
  </p:sldIdLst>
  <p:sldSz cx="6858000" cy="9144000" type="screen4x3"/>
  <p:notesSz cx="6881813" cy="100028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92" autoAdjust="0"/>
    <p:restoredTop sz="94700" autoAdjust="0"/>
  </p:normalViewPr>
  <p:slideViewPr>
    <p:cSldViewPr>
      <p:cViewPr varScale="1">
        <p:scale>
          <a:sx n="126" d="100"/>
          <a:sy n="126" d="100"/>
        </p:scale>
        <p:origin x="132" y="15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dela Hani Faiza" userId="55d59e65-77b9-4bba-b2b7-3471709ad582" providerId="ADAL" clId="{C6670AE7-9482-425C-BADE-4DB6B00CFB28}"/>
    <pc:docChg chg="undo custSel modSld">
      <pc:chgData name="Adela Hani Faiza" userId="55d59e65-77b9-4bba-b2b7-3471709ad582" providerId="ADAL" clId="{C6670AE7-9482-425C-BADE-4DB6B00CFB28}" dt="2018-12-06T01:28:33.675" v="395" actId="20577"/>
      <pc:docMkLst>
        <pc:docMk/>
      </pc:docMkLst>
      <pc:sldChg chg="modSp">
        <pc:chgData name="Adela Hani Faiza" userId="55d59e65-77b9-4bba-b2b7-3471709ad582" providerId="ADAL" clId="{C6670AE7-9482-425C-BADE-4DB6B00CFB28}" dt="2018-12-05T20:47:45.974" v="29" actId="6549"/>
        <pc:sldMkLst>
          <pc:docMk/>
          <pc:sldMk cId="252583807" sldId="256"/>
        </pc:sldMkLst>
        <pc:spChg chg="mod">
          <ac:chgData name="Adela Hani Faiza" userId="55d59e65-77b9-4bba-b2b7-3471709ad582" providerId="ADAL" clId="{C6670AE7-9482-425C-BADE-4DB6B00CFB28}" dt="2018-12-05T20:47:45.974" v="29" actId="6549"/>
          <ac:spMkLst>
            <pc:docMk/>
            <pc:sldMk cId="252583807" sldId="256"/>
            <ac:spMk id="17" creationId="{00000000-0000-0000-0000-000000000000}"/>
          </ac:spMkLst>
        </pc:spChg>
      </pc:sldChg>
      <pc:sldChg chg="modSp">
        <pc:chgData name="Adela Hani Faiza" userId="55d59e65-77b9-4bba-b2b7-3471709ad582" providerId="ADAL" clId="{C6670AE7-9482-425C-BADE-4DB6B00CFB28}" dt="2018-12-05T20:49:01.959" v="45" actId="207"/>
        <pc:sldMkLst>
          <pc:docMk/>
          <pc:sldMk cId="116284313" sldId="258"/>
        </pc:sldMkLst>
        <pc:spChg chg="mod">
          <ac:chgData name="Adela Hani Faiza" userId="55d59e65-77b9-4bba-b2b7-3471709ad582" providerId="ADAL" clId="{C6670AE7-9482-425C-BADE-4DB6B00CFB28}" dt="2018-12-05T20:49:01.959" v="45" actId="207"/>
          <ac:spMkLst>
            <pc:docMk/>
            <pc:sldMk cId="116284313" sldId="258"/>
            <ac:spMk id="12" creationId="{00000000-0000-0000-0000-000000000000}"/>
          </ac:spMkLst>
        </pc:spChg>
      </pc:sldChg>
      <pc:sldChg chg="modSp">
        <pc:chgData name="Adela Hani Faiza" userId="55d59e65-77b9-4bba-b2b7-3471709ad582" providerId="ADAL" clId="{C6670AE7-9482-425C-BADE-4DB6B00CFB28}" dt="2018-12-06T01:21:46.880" v="369" actId="113"/>
        <pc:sldMkLst>
          <pc:docMk/>
          <pc:sldMk cId="2477623704" sldId="259"/>
        </pc:sldMkLst>
        <pc:spChg chg="mod">
          <ac:chgData name="Adela Hani Faiza" userId="55d59e65-77b9-4bba-b2b7-3471709ad582" providerId="ADAL" clId="{C6670AE7-9482-425C-BADE-4DB6B00CFB28}" dt="2018-12-06T01:21:46.880" v="369" actId="113"/>
          <ac:spMkLst>
            <pc:docMk/>
            <pc:sldMk cId="2477623704" sldId="259"/>
            <ac:spMk id="44" creationId="{00000000-0000-0000-0000-000000000000}"/>
          </ac:spMkLst>
        </pc:spChg>
      </pc:sldChg>
      <pc:sldChg chg="modSp">
        <pc:chgData name="Adela Hani Faiza" userId="55d59e65-77b9-4bba-b2b7-3471709ad582" providerId="ADAL" clId="{C6670AE7-9482-425C-BADE-4DB6B00CFB28}" dt="2018-12-06T00:19:21.711" v="362" actId="207"/>
        <pc:sldMkLst>
          <pc:docMk/>
          <pc:sldMk cId="3198561535" sldId="260"/>
        </pc:sldMkLst>
        <pc:spChg chg="mod">
          <ac:chgData name="Adela Hani Faiza" userId="55d59e65-77b9-4bba-b2b7-3471709ad582" providerId="ADAL" clId="{C6670AE7-9482-425C-BADE-4DB6B00CFB28}" dt="2018-12-06T00:19:21.711" v="362" actId="207"/>
          <ac:spMkLst>
            <pc:docMk/>
            <pc:sldMk cId="3198561535" sldId="260"/>
            <ac:spMk id="21" creationId="{00000000-0000-0000-0000-000000000000}"/>
          </ac:spMkLst>
        </pc:spChg>
      </pc:sldChg>
      <pc:sldChg chg="modSp">
        <pc:chgData name="Adela Hani Faiza" userId="55d59e65-77b9-4bba-b2b7-3471709ad582" providerId="ADAL" clId="{C6670AE7-9482-425C-BADE-4DB6B00CFB28}" dt="2018-12-06T01:24:48.673" v="374" actId="20577"/>
        <pc:sldMkLst>
          <pc:docMk/>
          <pc:sldMk cId="2158975375" sldId="264"/>
        </pc:sldMkLst>
        <pc:spChg chg="mod">
          <ac:chgData name="Adela Hani Faiza" userId="55d59e65-77b9-4bba-b2b7-3471709ad582" providerId="ADAL" clId="{C6670AE7-9482-425C-BADE-4DB6B00CFB28}" dt="2018-12-06T01:24:48.673" v="374" actId="20577"/>
          <ac:spMkLst>
            <pc:docMk/>
            <pc:sldMk cId="2158975375" sldId="264"/>
            <ac:spMk id="26" creationId="{00000000-0000-0000-0000-000000000000}"/>
          </ac:spMkLst>
        </pc:spChg>
      </pc:sldChg>
      <pc:sldChg chg="modSp">
        <pc:chgData name="Adela Hani Faiza" userId="55d59e65-77b9-4bba-b2b7-3471709ad582" providerId="ADAL" clId="{C6670AE7-9482-425C-BADE-4DB6B00CFB28}" dt="2018-12-05T21:14:06.225" v="340"/>
        <pc:sldMkLst>
          <pc:docMk/>
          <pc:sldMk cId="3927315234" sldId="265"/>
        </pc:sldMkLst>
        <pc:spChg chg="mod">
          <ac:chgData name="Adela Hani Faiza" userId="55d59e65-77b9-4bba-b2b7-3471709ad582" providerId="ADAL" clId="{C6670AE7-9482-425C-BADE-4DB6B00CFB28}" dt="2018-12-05T21:14:06.225" v="340"/>
          <ac:spMkLst>
            <pc:docMk/>
            <pc:sldMk cId="3927315234" sldId="265"/>
            <ac:spMk id="26" creationId="{00000000-0000-0000-0000-000000000000}"/>
          </ac:spMkLst>
        </pc:spChg>
      </pc:sldChg>
      <pc:sldChg chg="modSp">
        <pc:chgData name="Adela Hani Faiza" userId="55d59e65-77b9-4bba-b2b7-3471709ad582" providerId="ADAL" clId="{C6670AE7-9482-425C-BADE-4DB6B00CFB28}" dt="2018-12-05T21:01:37.347" v="213" actId="207"/>
        <pc:sldMkLst>
          <pc:docMk/>
          <pc:sldMk cId="3189621390" sldId="271"/>
        </pc:sldMkLst>
        <pc:spChg chg="mod">
          <ac:chgData name="Adela Hani Faiza" userId="55d59e65-77b9-4bba-b2b7-3471709ad582" providerId="ADAL" clId="{C6670AE7-9482-425C-BADE-4DB6B00CFB28}" dt="2018-12-05T21:01:37.347" v="213" actId="207"/>
          <ac:spMkLst>
            <pc:docMk/>
            <pc:sldMk cId="3189621390" sldId="271"/>
            <ac:spMk id="11" creationId="{00000000-0000-0000-0000-000000000000}"/>
          </ac:spMkLst>
        </pc:spChg>
      </pc:sldChg>
      <pc:sldChg chg="modSp">
        <pc:chgData name="Adela Hani Faiza" userId="55d59e65-77b9-4bba-b2b7-3471709ad582" providerId="ADAL" clId="{C6670AE7-9482-425C-BADE-4DB6B00CFB28}" dt="2018-12-06T01:28:33.675" v="395" actId="20577"/>
        <pc:sldMkLst>
          <pc:docMk/>
          <pc:sldMk cId="2217151897" sldId="273"/>
        </pc:sldMkLst>
        <pc:spChg chg="mod">
          <ac:chgData name="Adela Hani Faiza" userId="55d59e65-77b9-4bba-b2b7-3471709ad582" providerId="ADAL" clId="{C6670AE7-9482-425C-BADE-4DB6B00CFB28}" dt="2018-12-06T01:28:33.675" v="395" actId="20577"/>
          <ac:spMkLst>
            <pc:docMk/>
            <pc:sldMk cId="2217151897" sldId="273"/>
            <ac:spMk id="5" creationId="{00000000-0000-0000-0000-000000000000}"/>
          </ac:spMkLst>
        </pc:spChg>
      </pc:sldChg>
      <pc:sldChg chg="modSp">
        <pc:chgData name="Adela Hani Faiza" userId="55d59e65-77b9-4bba-b2b7-3471709ad582" providerId="ADAL" clId="{C6670AE7-9482-425C-BADE-4DB6B00CFB28}" dt="2018-12-05T21:12:54.964" v="317" actId="207"/>
        <pc:sldMkLst>
          <pc:docMk/>
          <pc:sldMk cId="2111949357" sldId="274"/>
        </pc:sldMkLst>
        <pc:spChg chg="mod">
          <ac:chgData name="Adela Hani Faiza" userId="55d59e65-77b9-4bba-b2b7-3471709ad582" providerId="ADAL" clId="{C6670AE7-9482-425C-BADE-4DB6B00CFB28}" dt="2018-12-05T21:12:54.964" v="317" actId="207"/>
          <ac:spMkLst>
            <pc:docMk/>
            <pc:sldMk cId="2111949357" sldId="274"/>
            <ac:spMk id="17" creationId="{00000000-0000-0000-0000-000000000000}"/>
          </ac:spMkLst>
        </pc:spChg>
      </pc:sldChg>
      <pc:sldChg chg="modSp">
        <pc:chgData name="Adela Hani Faiza" userId="55d59e65-77b9-4bba-b2b7-3471709ad582" providerId="ADAL" clId="{C6670AE7-9482-425C-BADE-4DB6B00CFB28}" dt="2018-12-05T21:03:01.015" v="232" actId="207"/>
        <pc:sldMkLst>
          <pc:docMk/>
          <pc:sldMk cId="4203491829" sldId="276"/>
        </pc:sldMkLst>
        <pc:spChg chg="mod">
          <ac:chgData name="Adela Hani Faiza" userId="55d59e65-77b9-4bba-b2b7-3471709ad582" providerId="ADAL" clId="{C6670AE7-9482-425C-BADE-4DB6B00CFB28}" dt="2018-12-05T21:03:01.015" v="232" actId="207"/>
          <ac:spMkLst>
            <pc:docMk/>
            <pc:sldMk cId="4203491829" sldId="276"/>
            <ac:spMk id="8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500142"/>
          </a:xfrm>
          <a:prstGeom prst="rect">
            <a:avLst/>
          </a:prstGeom>
        </p:spPr>
        <p:txBody>
          <a:bodyPr vert="horz" lIns="96478" tIns="48239" rIns="96478" bIns="48239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500142"/>
          </a:xfrm>
          <a:prstGeom prst="rect">
            <a:avLst/>
          </a:prstGeom>
        </p:spPr>
        <p:txBody>
          <a:bodyPr vert="horz" lIns="96478" tIns="48239" rIns="96478" bIns="48239" rtlCol="0"/>
          <a:lstStyle>
            <a:lvl1pPr algn="r">
              <a:defRPr sz="1300"/>
            </a:lvl1pPr>
          </a:lstStyle>
          <a:p>
            <a:fld id="{D11238D0-2558-433F-8D36-E1F2377DFCE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35175" y="750888"/>
            <a:ext cx="2811463" cy="3749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478" tIns="48239" rIns="96478" bIns="48239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182" y="4751348"/>
            <a:ext cx="5505450" cy="4501277"/>
          </a:xfrm>
          <a:prstGeom prst="rect">
            <a:avLst/>
          </a:prstGeom>
        </p:spPr>
        <p:txBody>
          <a:bodyPr vert="horz" lIns="96478" tIns="48239" rIns="96478" bIns="48239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00960"/>
            <a:ext cx="2982119" cy="500142"/>
          </a:xfrm>
          <a:prstGeom prst="rect">
            <a:avLst/>
          </a:prstGeom>
        </p:spPr>
        <p:txBody>
          <a:bodyPr vert="horz" lIns="96478" tIns="48239" rIns="96478" bIns="48239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98102" y="9500960"/>
            <a:ext cx="2982119" cy="500142"/>
          </a:xfrm>
          <a:prstGeom prst="rect">
            <a:avLst/>
          </a:prstGeom>
        </p:spPr>
        <p:txBody>
          <a:bodyPr vert="horz" lIns="96478" tIns="48239" rIns="96478" bIns="48239" rtlCol="0" anchor="b"/>
          <a:lstStyle>
            <a:lvl1pPr algn="r">
              <a:defRPr sz="1300"/>
            </a:lvl1pPr>
          </a:lstStyle>
          <a:p>
            <a:fld id="{89AB0F61-5F56-4EC3-B3CC-EEE291E745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9334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9870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5392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7927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6167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1509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0033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6608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868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340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4832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7239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CD8197-F45F-4610-93DA-4CC8DA884D47}" type="datetimeFigureOut">
              <a:rPr lang="ko-KR" altLang="en-US" smtClean="0"/>
              <a:pPr/>
              <a:t>2019-05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BE647B-2D71-4E5A-A5DD-CB8D71133D1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9663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13" Type="http://schemas.openxmlformats.org/officeDocument/2006/relationships/image" Target="../media/image18.jpeg"/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12" Type="http://schemas.openxmlformats.org/officeDocument/2006/relationships/image" Target="../media/image17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jpeg"/><Relationship Id="rId11" Type="http://schemas.openxmlformats.org/officeDocument/2006/relationships/image" Target="../media/image16.png"/><Relationship Id="rId5" Type="http://schemas.openxmlformats.org/officeDocument/2006/relationships/image" Target="../media/image10.jpeg"/><Relationship Id="rId15" Type="http://schemas.openxmlformats.org/officeDocument/2006/relationships/image" Target="../media/image20.jpeg"/><Relationship Id="rId10" Type="http://schemas.openxmlformats.org/officeDocument/2006/relationships/image" Target="../media/image15.jpeg"/><Relationship Id="rId4" Type="http://schemas.openxmlformats.org/officeDocument/2006/relationships/image" Target="../media/image9.jpeg"/><Relationship Id="rId9" Type="http://schemas.openxmlformats.org/officeDocument/2006/relationships/image" Target="../media/image14.jpeg"/><Relationship Id="rId14" Type="http://schemas.openxmlformats.org/officeDocument/2006/relationships/image" Target="../media/image19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jpeg"/><Relationship Id="rId7" Type="http://schemas.openxmlformats.org/officeDocument/2006/relationships/image" Target="../media/image29.jpe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jpeg"/><Relationship Id="rId4" Type="http://schemas.openxmlformats.org/officeDocument/2006/relationships/image" Target="../media/image26.jpeg"/><Relationship Id="rId9" Type="http://schemas.openxmlformats.org/officeDocument/2006/relationships/image" Target="../media/image3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7" Type="http://schemas.openxmlformats.org/officeDocument/2006/relationships/image" Target="../media/image37.jpeg"/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jpeg"/><Relationship Id="rId5" Type="http://schemas.openxmlformats.org/officeDocument/2006/relationships/image" Target="../media/image35.jpeg"/><Relationship Id="rId4" Type="http://schemas.openxmlformats.org/officeDocument/2006/relationships/image" Target="../media/image3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제목 1"/>
          <p:cNvSpPr txBox="1">
            <a:spLocks/>
          </p:cNvSpPr>
          <p:nvPr/>
        </p:nvSpPr>
        <p:spPr>
          <a:xfrm>
            <a:off x="476672" y="5383341"/>
            <a:ext cx="5862849" cy="20162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20000"/>
              </a:lnSpc>
            </a:pP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ization with Ag alone without CT induced similar level of Ab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tion in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h WT and ERdj5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were immunized twice via the intranasal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ute with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µg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A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ne or together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1 µg CT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weeks intervals. At 7 days following final immunization,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 production were determined. (A) Following OVA alone immunization, the level of OVA-specific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 and IgA levels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he serum was determined. (B) Following intranasal immunization of OVA alone or CT combination, the level of OVA-specific IgA was determined in the mucosal secretions such as saliva and feces. (C) When ERdj5 KO mice were immunized with OVA or CT combination, the level of OVA-specific IgG and IgA in the serum was determined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ent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. *p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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0.05.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717032" y="441463"/>
            <a:ext cx="2823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Kim MS et al., Supplementary Figure 1</a:t>
            </a:r>
            <a:endParaRPr lang="ko-KR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그룹 7"/>
          <p:cNvGrpSpPr/>
          <p:nvPr/>
        </p:nvGrpSpPr>
        <p:grpSpPr>
          <a:xfrm>
            <a:off x="1464153" y="2437350"/>
            <a:ext cx="3461459" cy="1342562"/>
            <a:chOff x="1464153" y="3917580"/>
            <a:chExt cx="3461459" cy="1342562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64153" y="3925949"/>
              <a:ext cx="2107277" cy="1334193"/>
            </a:xfrm>
            <a:prstGeom prst="rect">
              <a:avLst/>
            </a:prstGeom>
          </p:spPr>
        </p:pic>
        <p:sp>
          <p:nvSpPr>
            <p:cNvPr id="16" name="직사각형 15"/>
            <p:cNvSpPr/>
            <p:nvPr/>
          </p:nvSpPr>
          <p:spPr>
            <a:xfrm>
              <a:off x="2517791" y="4120946"/>
              <a:ext cx="934518" cy="4413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80928" y="3917580"/>
              <a:ext cx="2144684" cy="1334193"/>
            </a:xfrm>
            <a:prstGeom prst="rect">
              <a:avLst/>
            </a:prstGeom>
          </p:spPr>
        </p:pic>
      </p:grpSp>
      <p:grpSp>
        <p:nvGrpSpPr>
          <p:cNvPr id="19" name="그룹 18"/>
          <p:cNvGrpSpPr/>
          <p:nvPr/>
        </p:nvGrpSpPr>
        <p:grpSpPr>
          <a:xfrm>
            <a:off x="1445450" y="1043608"/>
            <a:ext cx="3315986" cy="1334193"/>
            <a:chOff x="1445450" y="2469118"/>
            <a:chExt cx="3315986" cy="1334193"/>
          </a:xfrm>
        </p:grpSpPr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5450" y="2469118"/>
              <a:ext cx="2125980" cy="1334193"/>
            </a:xfrm>
            <a:prstGeom prst="rect">
              <a:avLst/>
            </a:prstGeom>
          </p:spPr>
        </p:pic>
        <p:sp>
          <p:nvSpPr>
            <p:cNvPr id="13" name="직사각형 12"/>
            <p:cNvSpPr/>
            <p:nvPr/>
          </p:nvSpPr>
          <p:spPr>
            <a:xfrm>
              <a:off x="2636912" y="2840410"/>
              <a:ext cx="934518" cy="3311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80928" y="2525229"/>
              <a:ext cx="1980508" cy="1278082"/>
            </a:xfrm>
            <a:prstGeom prst="rect">
              <a:avLst/>
            </a:prstGeom>
          </p:spPr>
        </p:pic>
      </p:grpSp>
      <p:grpSp>
        <p:nvGrpSpPr>
          <p:cNvPr id="15" name="그룹 14"/>
          <p:cNvGrpSpPr/>
          <p:nvPr/>
        </p:nvGrpSpPr>
        <p:grpSpPr>
          <a:xfrm>
            <a:off x="1453254" y="3851920"/>
            <a:ext cx="3412369" cy="1315489"/>
            <a:chOff x="1453254" y="1127801"/>
            <a:chExt cx="3412369" cy="1315489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3254" y="1157598"/>
              <a:ext cx="2252749" cy="1278082"/>
            </a:xfrm>
            <a:prstGeom prst="rect">
              <a:avLst/>
            </a:prstGeom>
          </p:spPr>
        </p:pic>
        <p:sp>
          <p:nvSpPr>
            <p:cNvPr id="17" name="직사각형 16"/>
            <p:cNvSpPr/>
            <p:nvPr/>
          </p:nvSpPr>
          <p:spPr>
            <a:xfrm>
              <a:off x="2636912" y="1403362"/>
              <a:ext cx="934518" cy="3311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8346" y="1127801"/>
              <a:ext cx="2107277" cy="1315489"/>
            </a:xfrm>
            <a:prstGeom prst="rect">
              <a:avLst/>
            </a:prstGeom>
          </p:spPr>
        </p:pic>
      </p:grpSp>
      <p:sp>
        <p:nvSpPr>
          <p:cNvPr id="18" name="TextBox 17"/>
          <p:cNvSpPr txBox="1"/>
          <p:nvPr/>
        </p:nvSpPr>
        <p:spPr>
          <a:xfrm>
            <a:off x="1330258" y="3707904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C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329949" y="2339752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329949" y="92712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96512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527" y="989538"/>
            <a:ext cx="2061972" cy="1506474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3502" y="974246"/>
            <a:ext cx="2160270" cy="1524762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3016" y="992534"/>
            <a:ext cx="2100834" cy="1506474"/>
          </a:xfrm>
          <a:prstGeom prst="rect">
            <a:avLst/>
          </a:prstGeom>
        </p:spPr>
      </p:pic>
      <p:sp>
        <p:nvSpPr>
          <p:cNvPr id="17" name="제목 1"/>
          <p:cNvSpPr txBox="1">
            <a:spLocks/>
          </p:cNvSpPr>
          <p:nvPr/>
        </p:nvSpPr>
        <p:spPr>
          <a:xfrm>
            <a:off x="520450" y="6906965"/>
            <a:ext cx="5862849" cy="198551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20000"/>
              </a:lnSpc>
            </a:pP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 production in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dj5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 mice decreased specifically following CT administration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were immunized twice via the intranasal route (A,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) or intraperitoneal route (B)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20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µg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A plus 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 µg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T (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, B)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CTB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2 weeks intervals. At 7 days following final immunization, Ag-specific IgG and IgA levels were determined from serum and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cosal secretions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T-specific IgG and IgA in the serum and fecal extract following CT plus OVA administration (n=6). Student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. *p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0.05, **p 0.01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OVA-specific IgG and IgA levels in serum and fecal extract following intraperitoneal administration of CT plus OVA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C) The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 of polyclonal immunoglobulin was determined from serum and mucosal secretion of naïve WT and ERdj5 KO mice (n=4).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B-specific IgG and IgA levels in serum and fecal extract following CTB plus OVA administration (n=5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717032" y="441463"/>
            <a:ext cx="2823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Kim MS et al., Supplementary Figure </a:t>
            </a:r>
            <a:r>
              <a:rPr lang="en-US" altLang="ko-K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14267" y="827584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그림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022" y="5441790"/>
            <a:ext cx="2139696" cy="1506474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1740" y="5395748"/>
            <a:ext cx="2160270" cy="1545336"/>
          </a:xfrm>
          <a:prstGeom prst="rect">
            <a:avLst/>
          </a:prstGeom>
        </p:spPr>
      </p:pic>
      <p:grpSp>
        <p:nvGrpSpPr>
          <p:cNvPr id="30" name="그룹 29"/>
          <p:cNvGrpSpPr/>
          <p:nvPr/>
        </p:nvGrpSpPr>
        <p:grpSpPr>
          <a:xfrm>
            <a:off x="859092" y="3866061"/>
            <a:ext cx="5549524" cy="1661922"/>
            <a:chOff x="859092" y="2420529"/>
            <a:chExt cx="5549524" cy="1661922"/>
          </a:xfrm>
        </p:grpSpPr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9092" y="2420529"/>
              <a:ext cx="2082546" cy="1661922"/>
            </a:xfrm>
            <a:prstGeom prst="rect">
              <a:avLst/>
            </a:prstGeom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90564" y="2453674"/>
              <a:ext cx="2139696" cy="1524762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18892" y="2455934"/>
              <a:ext cx="2139696" cy="1524762"/>
            </a:xfrm>
            <a:prstGeom prst="rect">
              <a:avLst/>
            </a:prstGeom>
          </p:spPr>
        </p:pic>
        <p:pic>
          <p:nvPicPr>
            <p:cNvPr id="15" name="그림 14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1561"/>
            <a:stretch/>
          </p:blipFill>
          <p:spPr>
            <a:xfrm>
              <a:off x="4554840" y="2455934"/>
              <a:ext cx="1250424" cy="1524762"/>
            </a:xfrm>
            <a:prstGeom prst="rect">
              <a:avLst/>
            </a:prstGeom>
          </p:spPr>
        </p:pic>
        <p:pic>
          <p:nvPicPr>
            <p:cNvPr id="22" name="그림 21"/>
            <p:cNvPicPr>
              <a:picLocks noChangeAspect="1"/>
            </p:cNvPicPr>
            <p:nvPr/>
          </p:nvPicPr>
          <p:blipFill rotWithShape="1">
            <a:blip r:embed="rId11"/>
            <a:srcRect l="66825" t="12204" b="68898"/>
            <a:stretch/>
          </p:blipFill>
          <p:spPr>
            <a:xfrm>
              <a:off x="5698716" y="2738691"/>
              <a:ext cx="709900" cy="288032"/>
            </a:xfrm>
            <a:prstGeom prst="rect">
              <a:avLst/>
            </a:prstGeom>
          </p:spPr>
        </p:pic>
      </p:grpSp>
      <p:grpSp>
        <p:nvGrpSpPr>
          <p:cNvPr id="29" name="그룹 28"/>
          <p:cNvGrpSpPr/>
          <p:nvPr/>
        </p:nvGrpSpPr>
        <p:grpSpPr>
          <a:xfrm>
            <a:off x="860565" y="2421417"/>
            <a:ext cx="5459635" cy="1334193"/>
            <a:chOff x="956875" y="5478006"/>
            <a:chExt cx="5459635" cy="1334193"/>
          </a:xfrm>
        </p:grpSpPr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6875" y="5478006"/>
              <a:ext cx="1602278" cy="1334193"/>
            </a:xfrm>
            <a:prstGeom prst="rect">
              <a:avLst/>
            </a:prstGeom>
          </p:spPr>
        </p:pic>
        <p:sp>
          <p:nvSpPr>
            <p:cNvPr id="24" name="직사각형 23"/>
            <p:cNvSpPr/>
            <p:nvPr/>
          </p:nvSpPr>
          <p:spPr>
            <a:xfrm>
              <a:off x="1856513" y="5724128"/>
              <a:ext cx="780399" cy="3600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8" name="그림 7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38"/>
            <a:stretch/>
          </p:blipFill>
          <p:spPr>
            <a:xfrm>
              <a:off x="2277321" y="5478006"/>
              <a:ext cx="1854467" cy="1334193"/>
            </a:xfrm>
            <a:prstGeom prst="rect">
              <a:avLst/>
            </a:prstGeom>
          </p:spPr>
        </p:pic>
        <p:sp>
          <p:nvSpPr>
            <p:cNvPr id="26" name="직사각형 25"/>
            <p:cNvSpPr/>
            <p:nvPr/>
          </p:nvSpPr>
          <p:spPr>
            <a:xfrm>
              <a:off x="3212976" y="5719743"/>
              <a:ext cx="780399" cy="3600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7155" y="5534117"/>
              <a:ext cx="1548246" cy="1278082"/>
            </a:xfrm>
            <a:prstGeom prst="rect">
              <a:avLst/>
            </a:prstGeom>
          </p:spPr>
        </p:pic>
        <p:sp>
          <p:nvSpPr>
            <p:cNvPr id="27" name="직사각형 26"/>
            <p:cNvSpPr/>
            <p:nvPr/>
          </p:nvSpPr>
          <p:spPr>
            <a:xfrm>
              <a:off x="4232777" y="5749170"/>
              <a:ext cx="780399" cy="3600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41495" y="5533668"/>
              <a:ext cx="1675015" cy="1278082"/>
            </a:xfrm>
            <a:prstGeom prst="rect">
              <a:avLst/>
            </a:prstGeom>
          </p:spPr>
        </p:pic>
      </p:grpSp>
      <p:sp>
        <p:nvSpPr>
          <p:cNvPr id="14" name="TextBox 13"/>
          <p:cNvSpPr txBox="1"/>
          <p:nvPr/>
        </p:nvSpPr>
        <p:spPr>
          <a:xfrm>
            <a:off x="814267" y="2267429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14267" y="3764786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C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814267" y="5363415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</a:rPr>
              <a:t>D</a:t>
            </a:r>
            <a:endParaRPr lang="ko-KR" altLang="en-US" sz="2000" b="1" dirty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19493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70" t="11841" r="48122" b="33754"/>
          <a:stretch/>
        </p:blipFill>
        <p:spPr>
          <a:xfrm>
            <a:off x="1393371" y="1349828"/>
            <a:ext cx="1297499" cy="1080000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229" t="12786" r="4480" b="34321"/>
          <a:stretch/>
        </p:blipFill>
        <p:spPr>
          <a:xfrm>
            <a:off x="2686822" y="2739670"/>
            <a:ext cx="1295610" cy="106071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16200000">
            <a:off x="909821" y="1660713"/>
            <a:ext cx="8178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Calibri" panose="020F0502020204030204" pitchFamily="34" charset="0"/>
                <a:cs typeface="Arial" panose="020B0604020202020204" pitchFamily="34" charset="0"/>
              </a:rPr>
              <a:t>Cell number</a:t>
            </a:r>
            <a:endParaRPr lang="ko-KR" altLang="en-US" sz="1000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938190" y="1206744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Calibri" panose="020F0502020204030204" pitchFamily="34" charset="0"/>
                <a:cs typeface="Arial" panose="020B0604020202020204" pitchFamily="34" charset="0"/>
              </a:rPr>
              <a:t>CD80</a:t>
            </a:r>
            <a:endParaRPr lang="ko-KR" altLang="en-US" sz="1000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239490" y="1478746"/>
            <a:ext cx="363882" cy="35907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ko-KR" sz="700" u="sng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CD80 MFI</a:t>
            </a:r>
            <a:endParaRPr lang="en-US" altLang="ko-KR" sz="700" u="sng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 Ctrl   6.8</a:t>
            </a: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008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WT   10.9</a:t>
            </a:r>
            <a:endParaRPr lang="en-US" altLang="ko-KR" sz="700" dirty="0">
              <a:solidFill>
                <a:srgbClr val="008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FF0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KO    11.3</a:t>
            </a:r>
            <a:endParaRPr lang="ko-KR" altLang="en-US" sz="700" dirty="0">
              <a:solidFill>
                <a:srgbClr val="FF0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279578" y="2559404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Calibri" panose="020F0502020204030204" pitchFamily="34" charset="0"/>
                <a:cs typeface="Arial" panose="020B0604020202020204" pitchFamily="34" charset="0"/>
              </a:rPr>
              <a:t>CD40</a:t>
            </a:r>
            <a:endParaRPr lang="ko-KR" altLang="en-US" sz="1000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55" t="13239" r="4236" b="30776"/>
          <a:stretch/>
        </p:blipFill>
        <p:spPr>
          <a:xfrm>
            <a:off x="1480181" y="2732427"/>
            <a:ext cx="1199172" cy="102892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938190" y="2559404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Calibri" panose="020F0502020204030204" pitchFamily="34" charset="0"/>
                <a:cs typeface="Arial" panose="020B0604020202020204" pitchFamily="34" charset="0"/>
              </a:rPr>
              <a:t>CD86</a:t>
            </a:r>
            <a:endParaRPr lang="ko-KR" altLang="en-US" sz="1000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107255" y="1206744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Calibri" panose="020F0502020204030204" pitchFamily="34" charset="0"/>
                <a:cs typeface="Arial" panose="020B0604020202020204" pitchFamily="34" charset="0"/>
              </a:rPr>
              <a:t>MHC class II</a:t>
            </a:r>
            <a:endParaRPr lang="ko-KR" altLang="en-US" sz="1000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43" t="17498" r="5771" b="8183"/>
          <a:stretch/>
        </p:blipFill>
        <p:spPr>
          <a:xfrm>
            <a:off x="2715908" y="1374897"/>
            <a:ext cx="1299367" cy="10440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 rot="16200000">
            <a:off x="989636" y="3021446"/>
            <a:ext cx="8178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Calibri" panose="020F0502020204030204" pitchFamily="34" charset="0"/>
                <a:cs typeface="Arial" panose="020B0604020202020204" pitchFamily="34" charset="0"/>
              </a:rPr>
              <a:t>Cell number</a:t>
            </a:r>
            <a:endParaRPr lang="ko-KR" altLang="en-US" sz="1000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989103" y="1478746"/>
            <a:ext cx="408766" cy="35907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ko-KR" sz="700" u="sng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MHC II MFI</a:t>
            </a:r>
            <a:endParaRPr lang="en-US" altLang="ko-KR" sz="700" u="sng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 Ctrl   4.9</a:t>
            </a: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008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WT   409</a:t>
            </a:r>
            <a:endParaRPr lang="en-US" altLang="ko-KR" sz="700" dirty="0">
              <a:solidFill>
                <a:srgbClr val="008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FF0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 KO   404</a:t>
            </a:r>
            <a:endParaRPr lang="ko-KR" altLang="en-US" sz="700" dirty="0">
              <a:solidFill>
                <a:srgbClr val="FF0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234727" y="2837492"/>
            <a:ext cx="354264" cy="35907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ko-KR" sz="700" u="sng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CD86 MFI</a:t>
            </a:r>
            <a:endParaRPr lang="en-US" altLang="ko-KR" sz="700" u="sng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 Ctrl   4.8</a:t>
            </a: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008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WT   99</a:t>
            </a:r>
            <a:endParaRPr lang="en-US" altLang="ko-KR" sz="700" dirty="0">
              <a:solidFill>
                <a:srgbClr val="008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FF0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 KO   85</a:t>
            </a:r>
            <a:endParaRPr lang="ko-KR" altLang="en-US" sz="700" dirty="0">
              <a:solidFill>
                <a:srgbClr val="FF0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529641" y="2837492"/>
            <a:ext cx="354264" cy="35907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ko-KR" sz="700" u="sng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CD40 MFI</a:t>
            </a:r>
            <a:endParaRPr lang="en-US" altLang="ko-KR" sz="700" u="sng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 Ctrl   3.2</a:t>
            </a: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008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WT   5.6</a:t>
            </a:r>
            <a:endParaRPr lang="en-US" altLang="ko-KR" sz="700" dirty="0">
              <a:solidFill>
                <a:srgbClr val="008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FF0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 KO   5.4</a:t>
            </a:r>
            <a:endParaRPr lang="ko-KR" altLang="en-US" sz="700" dirty="0">
              <a:solidFill>
                <a:srgbClr val="FF0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</p:txBody>
      </p:sp>
      <p:sp>
        <p:nvSpPr>
          <p:cNvPr id="16" name="제목 1"/>
          <p:cNvSpPr txBox="1">
            <a:spLocks/>
          </p:cNvSpPr>
          <p:nvPr/>
        </p:nvSpPr>
        <p:spPr>
          <a:xfrm>
            <a:off x="605500" y="3924912"/>
            <a:ext cx="5811744" cy="130483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20000"/>
              </a:lnSpc>
            </a:pP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ERdj5 KO DCs in absence of CT stimulation express similar levels of costimulatory molecules compared to WT DC.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Cs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isolated from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N of WT (green) or ERdj5 KO mice (red) at steady state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xpression levels of co-stimulatory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ecules including CD80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HC class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, CD86, and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0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D11c</a:t>
            </a: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Cs were determined.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y histogram denotes unstained control. Mean fluorescence intensity (MFI) from each histogram was presented.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702678" y="313076"/>
            <a:ext cx="2823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Kim MS et al., Supplementary Figure </a:t>
            </a:r>
            <a:r>
              <a:rPr lang="en-US" altLang="ko-K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02326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000610" y="111561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</a:rPr>
              <a:t>A</a:t>
            </a:r>
            <a:endParaRPr lang="ko-KR" altLang="en-US" sz="2000" b="1" dirty="0">
              <a:latin typeface="Calibri" panose="020F050202020403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219" y="1403648"/>
            <a:ext cx="1125906" cy="1116000"/>
          </a:xfrm>
          <a:prstGeom prst="rect">
            <a:avLst/>
          </a:prstGeom>
        </p:spPr>
      </p:pic>
      <p:pic>
        <p:nvPicPr>
          <p:cNvPr id="6" name="내용 개체 틀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5126" y="1210098"/>
            <a:ext cx="1237890" cy="151699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rot="16200000">
            <a:off x="771280" y="1816971"/>
            <a:ext cx="8178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Calibri" panose="020F0502020204030204" pitchFamily="34" charset="0"/>
                <a:cs typeface="Arial" panose="020B0604020202020204" pitchFamily="34" charset="0"/>
              </a:rPr>
              <a:t>Cell number</a:t>
            </a:r>
            <a:endParaRPr lang="ko-KR" altLang="en-US" sz="1000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566943" y="2454903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Calibri" panose="020F0502020204030204" pitchFamily="34" charset="0"/>
                <a:cs typeface="Arial" panose="020B0604020202020204" pitchFamily="34" charset="0"/>
              </a:rPr>
              <a:t>CD80</a:t>
            </a:r>
            <a:endParaRPr lang="ko-KR" altLang="en-US" sz="1000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그룹 29"/>
          <p:cNvGrpSpPr/>
          <p:nvPr/>
        </p:nvGrpSpPr>
        <p:grpSpPr>
          <a:xfrm>
            <a:off x="3514104" y="1209825"/>
            <a:ext cx="2425393" cy="1513706"/>
            <a:chOff x="3795864" y="1209825"/>
            <a:chExt cx="2425393" cy="1513706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26232" y="1405293"/>
              <a:ext cx="1125906" cy="111600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 rot="16200000">
              <a:off x="3510048" y="1816971"/>
              <a:ext cx="8178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Calibri" panose="020F0502020204030204" pitchFamily="34" charset="0"/>
                  <a:cs typeface="Arial" panose="020B0604020202020204" pitchFamily="34" charset="0"/>
                </a:rPr>
                <a:t>Cell number</a:t>
              </a:r>
              <a:endParaRPr lang="ko-KR" altLang="en-US" sz="10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55904" y="2454903"/>
              <a:ext cx="8082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Calibri" panose="020F0502020204030204" pitchFamily="34" charset="0"/>
                  <a:cs typeface="Arial" panose="020B0604020202020204" pitchFamily="34" charset="0"/>
                </a:rPr>
                <a:t>MHC class II</a:t>
              </a:r>
              <a:endParaRPr lang="ko-KR" altLang="en-US" sz="10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그림 2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06352" y="1209825"/>
              <a:ext cx="1214905" cy="1513706"/>
            </a:xfrm>
            <a:prstGeom prst="rect">
              <a:avLst/>
            </a:prstGeom>
          </p:spPr>
        </p:pic>
      </p:grpSp>
      <p:sp>
        <p:nvSpPr>
          <p:cNvPr id="24" name="TextBox 23"/>
          <p:cNvSpPr txBox="1"/>
          <p:nvPr/>
        </p:nvSpPr>
        <p:spPr>
          <a:xfrm>
            <a:off x="1019846" y="2771800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</a:rPr>
              <a:t>C</a:t>
            </a:r>
            <a:endParaRPr lang="ko-KR" altLang="en-US" sz="2000" b="1" dirty="0">
              <a:latin typeface="Calibri" panose="020F0502020204030204" pitchFamily="34" charset="0"/>
            </a:endParaRPr>
          </a:p>
        </p:txBody>
      </p:sp>
      <p:sp>
        <p:nvSpPr>
          <p:cNvPr id="26" name="제목 1"/>
          <p:cNvSpPr txBox="1">
            <a:spLocks/>
          </p:cNvSpPr>
          <p:nvPr/>
        </p:nvSpPr>
        <p:spPr>
          <a:xfrm>
            <a:off x="718246" y="4499992"/>
            <a:ext cx="5811744" cy="130483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20000"/>
              </a:lnSpc>
            </a:pP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enic DCs were not affected following intranasal CT immunization regardless of the presence of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dj5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were immunized via the intranasal route with 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 µg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T. DCs were isolated from the spleen at 3 days following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ization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3)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xpression levels of co-stimulatory molecules in CD11c</a:t>
            </a: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Cs were determined. (A) Expression levels of CD80. (B) Expression levels of MHC class II. (C) Expression levels of CD86. (D) Expression levels of CD40. 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702678" y="313076"/>
            <a:ext cx="2823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Kim MS et al., Supplementary Figure </a:t>
            </a:r>
            <a:r>
              <a:rPr lang="en-US" altLang="ko-K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그룹 28"/>
          <p:cNvGrpSpPr/>
          <p:nvPr/>
        </p:nvGrpSpPr>
        <p:grpSpPr>
          <a:xfrm>
            <a:off x="3501008" y="2778624"/>
            <a:ext cx="2506080" cy="1506474"/>
            <a:chOff x="3782768" y="3130710"/>
            <a:chExt cx="2506080" cy="1506474"/>
          </a:xfrm>
        </p:grpSpPr>
        <p:sp>
          <p:nvSpPr>
            <p:cNvPr id="13" name="TextBox 12"/>
            <p:cNvSpPr txBox="1"/>
            <p:nvPr/>
          </p:nvSpPr>
          <p:spPr>
            <a:xfrm rot="16200000">
              <a:off x="3496952" y="3754556"/>
              <a:ext cx="8178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Calibri" panose="020F0502020204030204" pitchFamily="34" charset="0"/>
                  <a:cs typeface="Arial" panose="020B0604020202020204" pitchFamily="34" charset="0"/>
                </a:rPr>
                <a:t>Cell number</a:t>
              </a:r>
              <a:endParaRPr lang="ko-KR" altLang="en-US" sz="10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263532" y="4352937"/>
              <a:ext cx="463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Calibri" panose="020F0502020204030204" pitchFamily="34" charset="0"/>
                  <a:cs typeface="Arial" panose="020B0604020202020204" pitchFamily="34" charset="0"/>
                </a:rPr>
                <a:t>CD40</a:t>
              </a:r>
              <a:endParaRPr lang="ko-KR" altLang="en-US" sz="10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9406" y="3385752"/>
              <a:ext cx="1002269" cy="97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그림 1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41276" y="3130710"/>
              <a:ext cx="1147572" cy="1506474"/>
            </a:xfrm>
            <a:prstGeom prst="rect">
              <a:avLst/>
            </a:prstGeom>
          </p:spPr>
        </p:pic>
      </p:grpSp>
      <p:grpSp>
        <p:nvGrpSpPr>
          <p:cNvPr id="28" name="그룹 27"/>
          <p:cNvGrpSpPr/>
          <p:nvPr/>
        </p:nvGrpSpPr>
        <p:grpSpPr>
          <a:xfrm>
            <a:off x="1075943" y="2771800"/>
            <a:ext cx="2426606" cy="1506474"/>
            <a:chOff x="885674" y="3123886"/>
            <a:chExt cx="2426606" cy="1506474"/>
          </a:xfrm>
        </p:grpSpPr>
        <p:sp>
          <p:nvSpPr>
            <p:cNvPr id="18" name="TextBox 17"/>
            <p:cNvSpPr txBox="1"/>
            <p:nvPr/>
          </p:nvSpPr>
          <p:spPr>
            <a:xfrm>
              <a:off x="1396554" y="4352937"/>
              <a:ext cx="463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Calibri" panose="020F0502020204030204" pitchFamily="34" charset="0"/>
                  <a:cs typeface="Arial" panose="020B0604020202020204" pitchFamily="34" charset="0"/>
                </a:rPr>
                <a:t>CD86</a:t>
              </a:r>
              <a:endParaRPr lang="ko-KR" altLang="en-US" sz="10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06540" y="3419872"/>
              <a:ext cx="999115" cy="979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그림 15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02986" y="3123886"/>
              <a:ext cx="1209294" cy="1506474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 rot="16200000">
              <a:off x="599858" y="3754556"/>
              <a:ext cx="8178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Calibri" panose="020F0502020204030204" pitchFamily="34" charset="0"/>
                  <a:cs typeface="Arial" panose="020B0604020202020204" pitchFamily="34" charset="0"/>
                </a:rPr>
                <a:t>Cell number</a:t>
              </a:r>
              <a:endParaRPr lang="ko-KR" altLang="en-US" sz="10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3429000" y="111561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</a:rPr>
              <a:t>B</a:t>
            </a:r>
            <a:endParaRPr lang="ko-KR" altLang="en-US" sz="2000" b="1" dirty="0">
              <a:latin typeface="Calibri" panose="020F05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429000" y="2771800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</a:rPr>
              <a:t>D</a:t>
            </a:r>
            <a:endParaRPr lang="ko-KR" altLang="en-US" sz="2000" b="1" dirty="0">
              <a:latin typeface="Calibri" panose="020F050202020403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876574" y="1550517"/>
            <a:ext cx="368691" cy="269304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ko-KR" sz="700" u="sng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CD80 MFI</a:t>
            </a:r>
            <a:endParaRPr lang="en-US" altLang="ko-KR" sz="700" u="sng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 WT 1383</a:t>
            </a:r>
            <a:endParaRPr lang="en-US" altLang="ko-KR" sz="700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FF0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KO   1714</a:t>
            </a:r>
            <a:endParaRPr lang="ko-KR" altLang="en-US" sz="700" dirty="0">
              <a:solidFill>
                <a:srgbClr val="FF0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880098" y="1547342"/>
            <a:ext cx="408766" cy="269304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ko-KR" sz="700" u="sng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MHC II MFI</a:t>
            </a:r>
            <a:endParaRPr lang="en-US" altLang="ko-KR" sz="700" u="sng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 WT  7961</a:t>
            </a:r>
            <a:endParaRPr lang="en-US" altLang="ko-KR" sz="700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FF0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KO   8537</a:t>
            </a:r>
            <a:endParaRPr lang="ko-KR" altLang="en-US" sz="700" dirty="0">
              <a:solidFill>
                <a:srgbClr val="FF0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897351" y="3096361"/>
            <a:ext cx="354264" cy="269304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ko-KR" sz="700" u="sng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CD86 MFI</a:t>
            </a:r>
            <a:endParaRPr lang="en-US" altLang="ko-KR" sz="700" u="sng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 WT  899</a:t>
            </a:r>
            <a:endParaRPr lang="en-US" altLang="ko-KR" sz="700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FF0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KO  1093</a:t>
            </a:r>
            <a:endParaRPr lang="ko-KR" altLang="en-US" sz="700" dirty="0">
              <a:solidFill>
                <a:srgbClr val="FF0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340815" y="3086836"/>
            <a:ext cx="354264" cy="269304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ko-KR" sz="700" u="sng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CD40 MFI</a:t>
            </a:r>
            <a:endParaRPr lang="en-US" altLang="ko-KR" sz="700" u="sng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latin typeface="Calibri" pitchFamily="34" charset="0"/>
                <a:ea typeface="HY중고딕" pitchFamily="18" charset="-127"/>
                <a:cs typeface="Times New Roman" pitchFamily="18" charset="0"/>
              </a:rPr>
              <a:t> WT 373</a:t>
            </a:r>
            <a:endParaRPr lang="en-US" altLang="ko-KR" sz="700" dirty="0"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  <a:p>
            <a:pPr>
              <a:lnSpc>
                <a:spcPts val="700"/>
              </a:lnSpc>
            </a:pPr>
            <a:r>
              <a:rPr lang="en-US" altLang="ko-KR" sz="700" dirty="0" smtClean="0">
                <a:solidFill>
                  <a:srgbClr val="FF0000"/>
                </a:solidFill>
                <a:latin typeface="Calibri" pitchFamily="34" charset="0"/>
                <a:ea typeface="HY중고딕" pitchFamily="18" charset="-127"/>
                <a:cs typeface="Times New Roman" pitchFamily="18" charset="0"/>
              </a:rPr>
              <a:t> KO  531</a:t>
            </a:r>
            <a:endParaRPr lang="ko-KR" altLang="en-US" sz="700" dirty="0">
              <a:solidFill>
                <a:srgbClr val="FF0000"/>
              </a:solidFill>
              <a:latin typeface="Calibri" pitchFamily="34" charset="0"/>
              <a:ea typeface="HY중고딕" pitchFamily="18" charset="-127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73152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3777136" y="327079"/>
            <a:ext cx="2823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Kim MS et al., Supplementary Figure </a:t>
            </a:r>
            <a:r>
              <a:rPr lang="en-US" altLang="ko-KR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제목 1"/>
          <p:cNvSpPr txBox="1">
            <a:spLocks/>
          </p:cNvSpPr>
          <p:nvPr/>
        </p:nvSpPr>
        <p:spPr>
          <a:xfrm>
            <a:off x="548680" y="4283968"/>
            <a:ext cx="5811744" cy="130483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1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20000"/>
              </a:lnSpc>
            </a:pP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 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kine production from splenic DCs were not affected following intranasal CT immunization regardless of the presence of </a:t>
            </a:r>
            <a:r>
              <a:rPr lang="en-US" altLang="ko-K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dj5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were immunized via the intranasal route with 20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µg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A and 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 µg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4)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s were isolated from the spleen at 3 days following CT immunization. Splenic CD11c</a:t>
            </a:r>
            <a:r>
              <a:rPr lang="en-US" altLang="ko-KR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Cs were stimulated with PMA/ionomycin for 18 h and then the levels of pro-inflammatory cytokines were determined. (A) TNF-</a:t>
            </a:r>
            <a:r>
              <a:rPr lang="el-GR" altLang="ko-KR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α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B) IL-6. (C) MCP-1. (D) IL-12p70. (E) IFN-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. (F) IL-1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20000"/>
              </a:lnSpc>
            </a:pP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9985" y="1187624"/>
            <a:ext cx="990877" cy="1459715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6259" y="1187624"/>
            <a:ext cx="990877" cy="1459715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2299" y="1187624"/>
            <a:ext cx="990877" cy="1459715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9985" y="2697934"/>
            <a:ext cx="990877" cy="1459715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6886" y="2697934"/>
            <a:ext cx="954301" cy="1459715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5734" y="2697934"/>
            <a:ext cx="1047404" cy="145971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583892" y="981754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719592" y="981754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836019" y="981754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C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583892" y="2414216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D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719592" y="2414216"/>
            <a:ext cx="309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E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836019" y="2414216"/>
            <a:ext cx="3016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Calibri" panose="020F0502020204030204" pitchFamily="34" charset="0"/>
                <a:cs typeface="Arial" panose="020B0604020202020204" pitchFamily="34" charset="0"/>
              </a:rPr>
              <a:t>F</a:t>
            </a:r>
            <a:endParaRPr lang="ko-KR" altLang="en-US" sz="2000" b="1" dirty="0">
              <a:latin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8561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753</TotalTime>
  <Words>772</Words>
  <Application>Microsoft Office PowerPoint</Application>
  <PresentationFormat>화면 슬라이드 쇼(4:3)</PresentationFormat>
  <Paragraphs>69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2" baseType="lpstr">
      <vt:lpstr>HY중고딕</vt:lpstr>
      <vt:lpstr>맑은 고딕</vt:lpstr>
      <vt:lpstr>Arial</vt:lpstr>
      <vt:lpstr>Calibri</vt:lpstr>
      <vt:lpstr>Symbo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Ajou</cp:lastModifiedBy>
  <cp:revision>317</cp:revision>
  <cp:lastPrinted>2018-09-07T04:16:06Z</cp:lastPrinted>
  <dcterms:created xsi:type="dcterms:W3CDTF">2018-02-14T21:06:26Z</dcterms:created>
  <dcterms:modified xsi:type="dcterms:W3CDTF">2019-05-24T01:49:48Z</dcterms:modified>
</cp:coreProperties>
</file>